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24" r:id="rId2"/>
    <p:sldId id="322" r:id="rId3"/>
    <p:sldId id="321" r:id="rId4"/>
    <p:sldId id="323" r:id="rId5"/>
  </p:sldIdLst>
  <p:sldSz cx="10058400" cy="73152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04" userDrawn="1">
          <p15:clr>
            <a:srgbClr val="A4A3A4"/>
          </p15:clr>
        </p15:guide>
        <p15:guide id="2" pos="31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00000"/>
    <a:srgbClr val="2E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6203" autoAdjust="0"/>
  </p:normalViewPr>
  <p:slideViewPr>
    <p:cSldViewPr>
      <p:cViewPr varScale="1">
        <p:scale>
          <a:sx n="104" d="100"/>
          <a:sy n="104" d="100"/>
        </p:scale>
        <p:origin x="114" y="144"/>
      </p:cViewPr>
      <p:guideLst>
        <p:guide orient="horz" pos="2304"/>
        <p:guide pos="316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FF74A7-4E0D-4884-B7F0-F98D22637EF6}" type="datetimeFigureOut">
              <a:rPr lang="en-US" smtClean="0"/>
              <a:t>12/1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096963" y="1241425"/>
            <a:ext cx="4603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7F437C-1068-4F5E-AA99-0145FAFEC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2467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2272455"/>
            <a:ext cx="8549640" cy="156802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8760" y="4145280"/>
            <a:ext cx="7040880" cy="18694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92340" y="292949"/>
            <a:ext cx="2263140" cy="624162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292949"/>
            <a:ext cx="6621780" cy="624162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4544" y="4700694"/>
            <a:ext cx="8549640" cy="145288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4544" y="3100495"/>
            <a:ext cx="8549640" cy="160019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706880"/>
            <a:ext cx="4442460" cy="48276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13020" y="1706880"/>
            <a:ext cx="4442460" cy="48276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637455"/>
            <a:ext cx="4444207" cy="6824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2920" y="2319868"/>
            <a:ext cx="4444207" cy="42147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9529" y="1637455"/>
            <a:ext cx="4445953" cy="6824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9529" y="2319868"/>
            <a:ext cx="4445953" cy="42147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2" y="291253"/>
            <a:ext cx="3309144" cy="123952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32555" y="291255"/>
            <a:ext cx="5622925" cy="62433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2922" y="1530775"/>
            <a:ext cx="3309144" cy="500380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1517" y="5120641"/>
            <a:ext cx="6035040" cy="60452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1517" y="653627"/>
            <a:ext cx="6035040" cy="438912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1517" y="5725162"/>
            <a:ext cx="6035040" cy="8585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292947"/>
            <a:ext cx="9052560" cy="1219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706880"/>
            <a:ext cx="9052560" cy="48276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6780108"/>
            <a:ext cx="234696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36620" y="6780108"/>
            <a:ext cx="318516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08520" y="6780108"/>
            <a:ext cx="234696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81000" y="6465249"/>
            <a:ext cx="9601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cosinolat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ents of leaf samples from ringspo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 (SCNU-C-049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NU-C-033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bbage lines under different treatment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: Control; M1: Mock day 1; T1: Treated day 1; M3: Mock day 3; T3: Treated day 3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ean of three biological replicates is presented. Vertical bars indicate standard deviation. Different letters indicate statistically significant differences betwee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 &amp; S lines and treatment interactions. Bar indicates total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inolat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ent in response to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lerotinia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lerotiorum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ection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: Resistant; S: Susceptible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00" y="457200"/>
            <a:ext cx="8458200" cy="59059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93535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032933" y="6570134"/>
            <a:ext cx="7685707" cy="7696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067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regulated genes of transcription factor related and </a:t>
            </a:r>
            <a:r>
              <a:rPr lang="en-US" sz="106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cosinolate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synthesis genes in White mold </a:t>
            </a:r>
            <a:r>
              <a:rPr lang="en-US" sz="1067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 </a:t>
            </a:r>
            <a:r>
              <a:rPr lang="en-US" sz="1067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NU-C-049</a:t>
            </a:r>
            <a:r>
              <a:rPr lang="en-US" sz="1067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067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S </a:t>
            </a:r>
            <a:r>
              <a:rPr lang="en-US" sz="1067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NU-C-</a:t>
            </a:r>
            <a:r>
              <a:rPr lang="en-US" sz="1067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33</a:t>
            </a:r>
            <a:r>
              <a:rPr lang="en-US" sz="1067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lines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cabbage .</a:t>
            </a:r>
            <a:r>
              <a:rPr lang="en-US" sz="1067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: Control; M1: Mock day 1; T1: Treated day 1; M3: Mock day 3; T3: Treated day 3</a:t>
            </a:r>
            <a:r>
              <a:rPr lang="en-US" sz="1067" dirty="0">
                <a:latin typeface="Times New Roman" panose="02020603050405020304" pitchFamily="18" charset="0"/>
              </a:rPr>
              <a:t>.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mean of three biological replicates is presented. Vertical bars indicate standard deviation. Different letters indicate statistically significant differences between R- &amp; S-lines and treatment interactions. </a:t>
            </a:r>
            <a:r>
              <a:rPr lang="en-US" sz="1067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: Resistant; S: Susceptible.</a:t>
            </a:r>
            <a:endParaRPr lang="en-US" sz="1067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33216"/>
            <a:ext cx="8580782" cy="6578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33071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58322" y="6477000"/>
            <a:ext cx="952362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onsistent response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 factor rela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inolat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synthesis genes 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ite mold 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CNU-C-049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NU-C-033) lines of cabbage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: Control; M1: Mock day 1; T1: Treated day 1; M3: Mock day 3; T3: Treated day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of three biological replicates is presente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Vertica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s indicate standar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viation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letters indicate statistically significant differences betwee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 &amp; S lines 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s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: Resistant; S: Susceptible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272" y="43960"/>
            <a:ext cx="8382000" cy="6426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87626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" y="152400"/>
            <a:ext cx="8659368" cy="5952744"/>
          </a:xfrm>
          <a:prstGeom prst="rect">
            <a:avLst/>
          </a:prstGeom>
        </p:spPr>
      </p:pic>
      <p:sp>
        <p:nvSpPr>
          <p:cNvPr id="5" name="Rectangle 5"/>
          <p:cNvSpPr>
            <a:spLocks noChangeArrowheads="1"/>
          </p:cNvSpPr>
          <p:nvPr/>
        </p:nvSpPr>
        <p:spPr bwMode="auto">
          <a:xfrm>
            <a:off x="152400" y="6126049"/>
            <a:ext cx="9677399" cy="10772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>
              <a:spcBef>
                <a:spcPct val="0"/>
              </a:spcBef>
              <a:buFontTx/>
              <a:buNone/>
            </a:pPr>
            <a:r>
              <a:rPr lang="en-US" alt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 </a:t>
            </a:r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cosinolate</a:t>
            </a:r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synthesis and related transcription factor genes </a:t>
            </a:r>
            <a:r>
              <a:rPr lang="en-US" alt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en-US" sz="16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een square box </a:t>
            </a:r>
            <a:r>
              <a:rPr lang="en-US" alt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en-US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d letters</a:t>
            </a:r>
            <a:r>
              <a:rPr lang="en-US" alt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zed in this work, with their positions in the aliphatic and </a:t>
            </a:r>
            <a:r>
              <a:rPr lang="en-US" alt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olic</a:t>
            </a:r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cosinolate</a:t>
            </a:r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SL) biosynthesis pathways indicated (Adopted from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u et al.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14,</a:t>
            </a:r>
            <a:r>
              <a:rPr lang="en-US" alt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i </a:t>
            </a:r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 </a:t>
            </a:r>
            <a:r>
              <a:rPr lang="en-US" alt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16, </a:t>
            </a:r>
            <a:r>
              <a:rPr lang="en-US" alt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o</a:t>
            </a:r>
            <a:r>
              <a:rPr lang="en-US" alt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Kim, 2017). </a:t>
            </a:r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total of 15 and 23 genes were selected from the aliphatic and </a:t>
            </a:r>
            <a:r>
              <a:rPr lang="en-US" alt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olic</a:t>
            </a:r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cosinolate</a:t>
            </a:r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synthesis pathways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41719865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043</TotalTime>
  <Words>338</Words>
  <Application>Microsoft Office PowerPoint</Application>
  <PresentationFormat>Custom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suf</dc:creator>
  <cp:lastModifiedBy>user</cp:lastModifiedBy>
  <cp:revision>364</cp:revision>
  <cp:lastPrinted>2018-09-29T03:03:20Z</cp:lastPrinted>
  <dcterms:created xsi:type="dcterms:W3CDTF">2006-08-16T00:00:00Z</dcterms:created>
  <dcterms:modified xsi:type="dcterms:W3CDTF">2018-12-13T01:21:45Z</dcterms:modified>
</cp:coreProperties>
</file>